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DPI" initials="M" lastIdx="2" clrIdx="0">
    <p:extLst>
      <p:ext uri="{19B8F6BF-5375-455C-9EA6-DF929625EA0E}">
        <p15:presenceInfo xmlns:p15="http://schemas.microsoft.com/office/powerpoint/2012/main" userId="MDP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10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527160B-823B-4416-9EDD-44F638B462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620BAF58-3173-419F-8EA0-DD61A82FB0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1F75B36-93E2-4707-8F7A-A9E733A83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40D79C3-BBAE-4777-A2BE-F1932DB99B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3620658-7A2B-4083-9F6E-86A283DA6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23078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D73BC9F-2F42-4FFC-ACEA-9BD11B4E2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9FFF4646-6F50-4E60-900B-C1BD906416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140B5E5D-5E4D-4B99-9559-01CC8DE6B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59737B5-F803-480B-B54B-281632D5F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643624FB-3448-49D1-B38E-34C50E881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04006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806F68BC-A492-439D-AD1E-C1B0B7C4DC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720FE531-E378-44C7-80C4-63EAD75992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C181EBC4-1671-4F3D-BEFA-07B9791FD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B106488-61B0-415A-919C-002485636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2694E6F-C536-4332-A8E3-3CC5F91D8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38010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BB92B66-A596-41EA-8D47-5EE17B7CC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F66A158-F2C1-4C75-8A56-849A4B5AA5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205AA48-D2A1-4984-B8FB-AF40059F4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348A64E-297F-412A-8250-1147F6334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2267F3F-9035-4E94-A467-D242E2871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68801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179423E-D145-416E-97FE-B4FE97B8D8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0A2D7849-95CB-47E0-9B16-426424A6A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F3D22AA-8659-4469-9CFE-34ACC455A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21939CA-19F2-4D8E-B78C-F980EBCE2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08A1DAD-2EF5-4803-83E6-975AF2CC5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271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B78D63E-7E30-4D6E-A1DA-4A26B3A41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A0F663E4-5299-4111-BB0F-A8A67B4EE4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C53F49DC-F312-4078-AC65-CBBF2D11C5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4841AA69-7FB3-4190-9E1B-0558F8F23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BF5E8A32-ACFC-4256-8A86-FC6E38056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37D1850E-7557-4DAC-B9C1-BF01924C5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08677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E5F1926-29B0-40C2-8B1C-B82703B71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80120CA8-54B5-4251-A597-CB68262623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67D96755-BC72-4A5A-8668-4A4D018005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F3C7A072-CB3F-4BE4-A349-72250FEB1F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91DF1C17-8ABA-4704-B4CA-A4DA65C855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C13F9B5B-62B7-4A6C-8E72-908FFB411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7059554C-5FE4-48A3-A401-AC18794A3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65E77AFC-9BBB-40C2-8E61-9EC267C86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71156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38FEC47-23DE-4B03-8A86-E2E7699E93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170E7F95-6F95-4CC3-B2A8-AF6302F15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57CFA89A-D9A1-4DD8-8C6D-103C0F2FA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6EDE5DEE-FECB-4D09-8328-F91C8C5D2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97908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156F76FC-AC5B-4765-BD2B-7F6ECADD1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6A788AF8-7EDE-456B-A904-D6AAFCDA6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BE436E64-E5B0-4FF5-850F-37701D651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83324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D16BF56-48F6-4D54-A937-F7A7FF1BEE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9B40B6F8-A96E-4F73-99D2-EFFB9B4B2D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27FF61EB-988B-4332-A606-F6DD9FBA57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1C4EFD02-6A24-467A-AC6F-98C4A32C0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E26D633F-2EE2-4CD1-B6B7-07B1CB9C7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349136C9-CCFF-485D-91AC-44A99A2DA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843190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FE967C8-D532-483C-A393-12A97C21FA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D4ADEC36-C5DF-401A-916A-3833B6163F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68C7D529-F4CE-460D-A8A6-CE829B0F4E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8D965600-ED83-4A41-BA70-8DBEF22B1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BF120770-71BB-4344-9D6C-ACA2B991B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E5300480-406E-47F7-A8EF-B633A2C28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68783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0FDC0713-09B8-4D05-B80E-21C1A67DC7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D61522B8-CF99-4E6F-91D5-94AEFE5C5C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1A9FF578-F347-4206-BABD-31EB5CD1A3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9EF12-1EF9-45C1-8A58-3F1294E46B7D}" type="datetimeFigureOut">
              <a:rPr lang="hu-HU" smtClean="0"/>
              <a:t>2021. 02. 05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D401C616-8336-4CF2-AA0D-05D8C9AE6C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E38E089-EFD0-42BF-A18A-9545806F2B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4D731-0D24-44D4-90FD-070D096530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20322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>
            <a:extLst>
              <a:ext uri="{FF2B5EF4-FFF2-40B4-BE49-F238E27FC236}">
                <a16:creationId xmlns:a16="http://schemas.microsoft.com/office/drawing/2014/main" id="{184AA117-0367-487A-907B-115B4397C9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01692" y="1106909"/>
            <a:ext cx="4482751" cy="3242400"/>
          </a:xfrm>
          <a:prstGeom prst="rect">
            <a:avLst/>
          </a:prstGeom>
        </p:spPr>
      </p:pic>
      <p:pic>
        <p:nvPicPr>
          <p:cNvPr id="5" name="Kép 4">
            <a:extLst>
              <a:ext uri="{FF2B5EF4-FFF2-40B4-BE49-F238E27FC236}">
                <a16:creationId xmlns:a16="http://schemas.microsoft.com/office/drawing/2014/main" id="{E8E72436-13C1-4B8B-B94D-32861CA28C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4879" y="1106909"/>
            <a:ext cx="4586241" cy="3356700"/>
          </a:xfrm>
          <a:prstGeom prst="rect">
            <a:avLst/>
          </a:prstGeom>
        </p:spPr>
      </p:pic>
      <p:sp>
        <p:nvSpPr>
          <p:cNvPr id="2" name="Szövegdoboz 1">
            <a:extLst>
              <a:ext uri="{FF2B5EF4-FFF2-40B4-BE49-F238E27FC236}">
                <a16:creationId xmlns:a16="http://schemas.microsoft.com/office/drawing/2014/main" id="{3D0F51A6-981C-4EF7-A262-B7FB92C8C88D}"/>
              </a:ext>
            </a:extLst>
          </p:cNvPr>
          <p:cNvSpPr txBox="1"/>
          <p:nvPr/>
        </p:nvSpPr>
        <p:spPr>
          <a:xfrm>
            <a:off x="808037" y="4735428"/>
            <a:ext cx="1012054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1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PAO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verexpression 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dn’t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fluence the conversion 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te </a:t>
            </a:r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lateral root primordia into shoots. </a:t>
            </a:r>
            <a:r>
              <a:rPr lang="hu-HU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lative mRNA level of 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hu-HU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O2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in wild type (Col) and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PAO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overexpressing seedling roots</a:t>
            </a:r>
            <a:r>
              <a:rPr lang="hu-HU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/>
              <a:t>The mRNA level of  the </a:t>
            </a:r>
            <a:r>
              <a:rPr lang="en-US" sz="1400" i="1" dirty="0"/>
              <a:t>UBIQUITIN 1</a:t>
            </a:r>
            <a:r>
              <a:rPr lang="en-US" sz="1400" dirty="0"/>
              <a:t> (</a:t>
            </a:r>
            <a:r>
              <a:rPr lang="en-US" sz="1400" i="1" dirty="0"/>
              <a:t>At3G52590</a:t>
            </a:r>
            <a:r>
              <a:rPr lang="en-US" sz="1400" dirty="0"/>
              <a:t>) gene w</a:t>
            </a:r>
            <a:r>
              <a:rPr lang="hu-HU" sz="1400" dirty="0"/>
              <a:t>as</a:t>
            </a:r>
            <a:r>
              <a:rPr lang="en-US" sz="1400" dirty="0"/>
              <a:t> used for normalization. Data were averaged from three independent biological </a:t>
            </a:r>
            <a:r>
              <a:rPr lang="hu-HU" sz="1400" dirty="0"/>
              <a:t>samples </a:t>
            </a:r>
            <a:r>
              <a:rPr lang="en-US" sz="1400" dirty="0"/>
              <a:t>with three</a:t>
            </a:r>
            <a:r>
              <a:rPr lang="hu-HU" sz="1400" dirty="0"/>
              <a:t> </a:t>
            </a:r>
            <a:r>
              <a:rPr lang="en-US" sz="1400" dirty="0"/>
              <a:t>technical replicates </a:t>
            </a:r>
            <a:r>
              <a:rPr lang="hu-HU" sz="1400" dirty="0"/>
              <a:t>each</a:t>
            </a:r>
            <a:r>
              <a:rPr lang="en-US" sz="1400" dirty="0"/>
              <a:t>. </a:t>
            </a:r>
            <a:r>
              <a:rPr lang="hu-HU" sz="1400" dirty="0"/>
              <a:t>b) </a:t>
            </a:r>
            <a:r>
              <a:rPr lang="en-US" sz="1400" dirty="0"/>
              <a:t>Shoot regeneration of WT (Col) and </a:t>
            </a:r>
            <a:r>
              <a:rPr lang="en-US" sz="1400" dirty="0" err="1"/>
              <a:t>AtPAO</a:t>
            </a:r>
            <a:r>
              <a:rPr lang="hu-HU" sz="1400" dirty="0"/>
              <a:t>2</a:t>
            </a:r>
            <a:r>
              <a:rPr lang="en-US" sz="1400" dirty="0"/>
              <a:t> overexpressing transgenic (35S::PAO</a:t>
            </a:r>
            <a:r>
              <a:rPr lang="hu-HU" sz="1400" dirty="0"/>
              <a:t>2</a:t>
            </a:r>
            <a:r>
              <a:rPr lang="en-US" sz="1400" dirty="0"/>
              <a:t>)</a:t>
            </a:r>
            <a:r>
              <a:rPr lang="hu-HU" sz="1400" dirty="0"/>
              <a:t> </a:t>
            </a:r>
            <a:r>
              <a:rPr lang="en-US" sz="1400" dirty="0"/>
              <a:t>seedling roots 10 days after cytokinin induction.</a:t>
            </a:r>
            <a:r>
              <a:rPr lang="hu-HU" sz="1400" dirty="0"/>
              <a:t> </a:t>
            </a:r>
            <a:r>
              <a:rPr lang="en-US" sz="1400" dirty="0"/>
              <a:t>Data were averaged from </a:t>
            </a:r>
            <a:r>
              <a:rPr lang="hu-HU" sz="1400" dirty="0"/>
              <a:t>twenty </a:t>
            </a:r>
            <a:r>
              <a:rPr lang="en-US" sz="1400" dirty="0"/>
              <a:t>independent biological </a:t>
            </a:r>
            <a:r>
              <a:rPr lang="hu-HU" sz="1400" dirty="0"/>
              <a:t>samples. </a:t>
            </a:r>
          </a:p>
          <a:p>
            <a:r>
              <a:rPr lang="en-US" sz="1400" dirty="0"/>
              <a:t>Standard errors are shown on the columns. The significance of difference was </a:t>
            </a:r>
            <a:r>
              <a:rPr lang="hu-HU" sz="1400" dirty="0"/>
              <a:t>investigated </a:t>
            </a:r>
            <a:r>
              <a:rPr lang="en-US" sz="1400" dirty="0"/>
              <a:t>by Student’s t-test (*P≤0.05, **P≤0.01, ***P≤0.001). .</a:t>
            </a:r>
            <a:endParaRPr lang="hu-HU" sz="14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2551777-BCBA-45DF-A28E-9C141E3C4B86}"/>
              </a:ext>
            </a:extLst>
          </p:cNvPr>
          <p:cNvSpPr/>
          <p:nvPr/>
        </p:nvSpPr>
        <p:spPr>
          <a:xfrm>
            <a:off x="1489598" y="1381263"/>
            <a:ext cx="408374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2.5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656FE72-F6D5-4035-B88C-BD9DF8440D42}"/>
              </a:ext>
            </a:extLst>
          </p:cNvPr>
          <p:cNvSpPr/>
          <p:nvPr/>
        </p:nvSpPr>
        <p:spPr>
          <a:xfrm>
            <a:off x="1489598" y="1864025"/>
            <a:ext cx="408374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2.0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10D3385-0303-44BE-B233-2256041234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3963" y="1399371"/>
            <a:ext cx="828675" cy="2771775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15F36C26-390F-4B5B-AF9A-9FDCB1CB0DAB}"/>
              </a:ext>
            </a:extLst>
          </p:cNvPr>
          <p:cNvSpPr/>
          <p:nvPr/>
        </p:nvSpPr>
        <p:spPr>
          <a:xfrm>
            <a:off x="1489598" y="2391895"/>
            <a:ext cx="408374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1.5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1E4C577-AD9A-4113-AEEB-7F9C7B162936}"/>
              </a:ext>
            </a:extLst>
          </p:cNvPr>
          <p:cNvSpPr/>
          <p:nvPr/>
        </p:nvSpPr>
        <p:spPr>
          <a:xfrm>
            <a:off x="1489598" y="2874657"/>
            <a:ext cx="408374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1.0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551D0A4-E011-45CD-B539-9B13DAF9760B}"/>
              </a:ext>
            </a:extLst>
          </p:cNvPr>
          <p:cNvSpPr/>
          <p:nvPr/>
        </p:nvSpPr>
        <p:spPr>
          <a:xfrm>
            <a:off x="1489598" y="3405297"/>
            <a:ext cx="408374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0.5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EE3A23F-22F1-4645-A610-270D493650C5}"/>
              </a:ext>
            </a:extLst>
          </p:cNvPr>
          <p:cNvSpPr/>
          <p:nvPr/>
        </p:nvSpPr>
        <p:spPr>
          <a:xfrm>
            <a:off x="1495231" y="3909154"/>
            <a:ext cx="408374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0.0</a:t>
            </a:r>
          </a:p>
        </p:txBody>
      </p:sp>
    </p:spTree>
    <p:extLst>
      <p:ext uri="{BB962C8B-B14F-4D97-AF65-F5344CB8AC3E}">
        <p14:creationId xmlns:p14="http://schemas.microsoft.com/office/powerpoint/2010/main" val="1646301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49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-téma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Attila Fehér</dc:creator>
  <cp:lastModifiedBy>MDPI</cp:lastModifiedBy>
  <cp:revision>6</cp:revision>
  <dcterms:created xsi:type="dcterms:W3CDTF">2021-01-28T14:56:15Z</dcterms:created>
  <dcterms:modified xsi:type="dcterms:W3CDTF">2021-02-05T09:32:02Z</dcterms:modified>
</cp:coreProperties>
</file>